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jpeg" ContentType="image/jpeg"/>
  <Override PartName="/ppt/media/image4.png" ContentType="image/png"/>
  <Override PartName="/ppt/embeddings/oleObject1.docx" ContentType="application/vnd.openxmlformats-officedocument.wordprocessingml.documen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BD7279-7B16-42D2-9128-961E9D03DE3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DAD1F5-36E7-4500-A605-CF2ECBD6331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FC8C57-8963-4C9A-A6B8-D536BCFECEA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695B88-258A-4459-94F4-9C882E8FC10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9F69A6-114B-49C3-AE3E-D24DDAE6DEF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9D8243-BEB4-4448-9540-E1DD82E917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FEC3FB-3117-4AB5-B4F9-7B585430A94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68995E-CE13-4397-862C-36973E9CE6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8A29C8-6402-42FD-BF81-B8ECB1D795F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CB3A2C-F881-4C7E-9F6E-6EDC164A72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23F7C1-39E6-4D2B-AD85-DEB380C577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B02989-88BA-462C-B5F8-E710B3CE6A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A785BDC-AD58-4CC8-AB96-52ABD8BF33BF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package" Target="../embeddings/oleObject1.docx"/><Relationship Id="rId5" Type="http://schemas.openxmlformats.org/officeDocument/2006/relationships/image" Target="../media/image4.png"/><Relationship Id="rId6" Type="http://schemas.openxmlformats.org/officeDocument/2006/relationships/image" Target="../media/image1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0" t="0" r="56761" b="0"/>
          <a:stretch/>
        </p:blipFill>
        <p:spPr>
          <a:xfrm>
            <a:off x="7488360" y="1676520"/>
            <a:ext cx="1049040" cy="2854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2" name="" descr=""/>
          <p:cNvPicPr/>
          <p:nvPr/>
        </p:nvPicPr>
        <p:blipFill>
          <a:blip r:embed="rId2">
            <a:lum bright="-2000"/>
          </a:blip>
          <a:srcRect l="0" t="9372" r="0" b="18744"/>
          <a:stretch/>
        </p:blipFill>
        <p:spPr>
          <a:xfrm>
            <a:off x="1620720" y="1677960"/>
            <a:ext cx="4496040" cy="2840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3" name="" descr=""/>
          <p:cNvPicPr/>
          <p:nvPr/>
        </p:nvPicPr>
        <p:blipFill>
          <a:blip r:embed="rId3"/>
          <a:srcRect l="0" t="-18266" r="0" b="-18266"/>
          <a:stretch/>
        </p:blipFill>
        <p:spPr>
          <a:xfrm>
            <a:off x="6243480" y="1611360"/>
            <a:ext cx="1143000" cy="38412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7412040" y="1460520"/>
            <a:ext cx="762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1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7767720" y="1460520"/>
            <a:ext cx="685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1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8172360" y="1460520"/>
            <a:ext cx="420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325440" y="1460520"/>
            <a:ext cx="762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1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1125360" y="1465200"/>
            <a:ext cx="420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681120" y="1460520"/>
            <a:ext cx="685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1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6165720" y="1455840"/>
            <a:ext cx="762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1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6546960" y="1455840"/>
            <a:ext cx="685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1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6978600" y="1455840"/>
            <a:ext cx="420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1569960" y="1471680"/>
            <a:ext cx="762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1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1925640" y="1471680"/>
            <a:ext cx="685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1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2319480" y="1471680"/>
            <a:ext cx="420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2725560" y="1471680"/>
            <a:ext cx="762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1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3081240" y="1471680"/>
            <a:ext cx="685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1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3513240" y="1471680"/>
            <a:ext cx="420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3828960" y="1471680"/>
            <a:ext cx="762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1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4184640" y="1471680"/>
            <a:ext cx="685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1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4603680" y="1471680"/>
            <a:ext cx="420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4946760" y="1474920"/>
            <a:ext cx="761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1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5302080" y="1474920"/>
            <a:ext cx="685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1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5721480" y="1474920"/>
            <a:ext cx="420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7500960" y="1468440"/>
            <a:ext cx="914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6294600" y="1467000"/>
            <a:ext cx="914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439560" y="1473120"/>
            <a:ext cx="990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1671480" y="1479600"/>
            <a:ext cx="914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2814480" y="1479600"/>
            <a:ext cx="914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3919680" y="1479600"/>
            <a:ext cx="914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5049720" y="1479600"/>
            <a:ext cx="914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7719840" y="127332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oVo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442800" y="1270080"/>
            <a:ext cx="982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LO 320DM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>
            <a:off x="6474600" y="1263600"/>
            <a:ext cx="560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CA-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>
            <a:off x="1851480" y="127332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LD-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>
            <a:off x="2940840" y="1273320"/>
            <a:ext cx="63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DC-5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>
            <a:off x="4083840" y="1273320"/>
            <a:ext cx="63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DC-5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>
            <a:off x="5150880" y="1273320"/>
            <a:ext cx="63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DC-7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79" name=""/>
          <p:cNvGraphicFramePr/>
          <p:nvPr/>
        </p:nvGraphicFramePr>
        <p:xfrm>
          <a:off x="401760" y="2209680"/>
          <a:ext cx="4951440" cy="2316240"/>
        </p:xfrm>
        <a:graphic>
          <a:graphicData uri="http://schemas.openxmlformats.org/presentationml/2006/ole">
            <p:oleObj progId="Word.Document.12" r:id="rId4" spid="">
              <p:embed/>
              <p:pic>
                <p:nvPicPr>
                  <p:cNvPr id="80" name="" descr=""/>
                  <p:cNvPicPr/>
                  <p:nvPr/>
                </p:nvPicPr>
                <p:blipFill>
                  <a:blip r:embed="rId5"/>
                  <a:stretch/>
                </p:blipFill>
                <p:spPr>
                  <a:xfrm>
                    <a:off x="401760" y="2209680"/>
                    <a:ext cx="4951440" cy="2316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pic>
        <p:nvPicPr>
          <p:cNvPr id="81" name="" descr=""/>
          <p:cNvPicPr/>
          <p:nvPr/>
        </p:nvPicPr>
        <p:blipFill>
          <a:blip r:embed="rId6"/>
          <a:srcRect l="55092" t="0" r="0" b="0"/>
          <a:stretch/>
        </p:blipFill>
        <p:spPr>
          <a:xfrm>
            <a:off x="393840" y="1676520"/>
            <a:ext cx="1090440" cy="2854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82" name=""/>
          <p:cNvSpPr/>
          <p:nvPr/>
        </p:nvSpPr>
        <p:spPr>
          <a:xfrm>
            <a:off x="6218280" y="1657440"/>
            <a:ext cx="1143000" cy="3045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>
            <a:off x="8509680" y="1701720"/>
            <a:ext cx="642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al174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>
            <a:off x="268200" y="1935000"/>
            <a:ext cx="111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 rot="66000">
            <a:off x="18000" y="181080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9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"/>
          <p:cNvSpPr/>
          <p:nvPr/>
        </p:nvSpPr>
        <p:spPr>
          <a:xfrm>
            <a:off x="3679920" y="3497400"/>
            <a:ext cx="18396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"/>
          <p:cNvSpPr/>
          <p:nvPr/>
        </p:nvSpPr>
        <p:spPr>
          <a:xfrm>
            <a:off x="5089680" y="3184560"/>
            <a:ext cx="18396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"/>
          <p:cNvSpPr/>
          <p:nvPr/>
        </p:nvSpPr>
        <p:spPr>
          <a:xfrm>
            <a:off x="3429000" y="2136600"/>
            <a:ext cx="5105520" cy="2649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Detection of Val1744NICD in fractions of CRC cell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To enhance the sensitivity of detection for Val1744NICD, cells from CRC cell lines indicated were fractionated as described in Methods and 50 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g of protein from each fraction was analysed after SDS-PAGE by Western Blotting with anti-Val1744-NICD. P1 nuclear protein extracts were made with RIPA buffer since initial experiments indicated that only a small fractionVal1744-NICD-immunoreactive protein in the P1 fractions could be extracted with a standard high salt extraction procedure commonly used for many transcription factors. It is also noteworthy that some cells lacked detectable Val1744-NICD protein in the P1 fraction but showed a corresponding band in another fraction (see for example HDC-57). These cell lines were designated as ‘Val1744-NICD nega-tive’ since nuclear translocation of the NICD appears to be required for its function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9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8-22T13:03:35Z</dcterms:created>
  <dc:creator>pthomas cruk</dc:creator>
  <dc:description/>
  <dc:language>en-US</dc:language>
  <cp:lastModifiedBy>crukuser</cp:lastModifiedBy>
  <cp:lastPrinted>2008-10-09T13:42:18Z</cp:lastPrinted>
  <dcterms:modified xsi:type="dcterms:W3CDTF">2008-10-23T10:42:51Z</dcterms:modified>
  <cp:revision>74</cp:revision>
  <dc:subject/>
  <dc:title>PowerPoint Presentation</dc:title>
</cp:coreProperties>
</file>